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62" autoAdjust="0"/>
    <p:restoredTop sz="94660"/>
  </p:normalViewPr>
  <p:slideViewPr>
    <p:cSldViewPr snapToGrid="0">
      <p:cViewPr varScale="1">
        <p:scale>
          <a:sx n="58" d="100"/>
          <a:sy n="58" d="100"/>
        </p:scale>
        <p:origin x="9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736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75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435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938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252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252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604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737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190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677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73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3BF43-9B66-42E1-8368-5513A1C52BC8}" type="datetimeFigureOut">
              <a:rPr lang="en-US" smtClean="0"/>
              <a:t>12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E60FF-7059-4C2A-9FCD-7FF514BA7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169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143000"/>
            <a:ext cx="9144000" cy="4572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428393" y="5935287"/>
            <a:ext cx="7335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:  Figure 1 data with display of individual data points. 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235687" y="790293"/>
            <a:ext cx="15116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 cell ELISPOT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838584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2102" y="185234"/>
            <a:ext cx="6400800" cy="320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2102" y="3501428"/>
            <a:ext cx="6400800" cy="32004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428393" y="6483912"/>
            <a:ext cx="7522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2:  Figure 2 data with display of individual data points. 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549098" y="-49307"/>
            <a:ext cx="4422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Influenza </a:t>
            </a:r>
            <a:r>
              <a:rPr lang="en-US" b="1" dirty="0" err="1" smtClean="0"/>
              <a:t>Hemagglutination</a:t>
            </a:r>
            <a:r>
              <a:rPr lang="en-US" b="1" dirty="0" smtClean="0"/>
              <a:t>-Inhibition Assay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549098" y="3287633"/>
            <a:ext cx="3659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Influenza Virus Neutralization Assay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3007402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6429" y="893618"/>
            <a:ext cx="4572000" cy="4572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9775" y="893618"/>
            <a:ext cx="4572000" cy="4572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428393" y="5868787"/>
            <a:ext cx="7522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2:  Figure 4B data with display of individual data points. 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936429" y="490449"/>
            <a:ext cx="32175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D4+ T cell and NK cell % by sex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6128284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2</Words>
  <Application>Microsoft Office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ID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Voigt</dc:creator>
  <cp:lastModifiedBy>Emily Voigt</cp:lastModifiedBy>
  <cp:revision>5</cp:revision>
  <dcterms:created xsi:type="dcterms:W3CDTF">2018-12-14T00:42:14Z</dcterms:created>
  <dcterms:modified xsi:type="dcterms:W3CDTF">2018-12-14T00:52:52Z</dcterms:modified>
</cp:coreProperties>
</file>